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0" autoAdjust="0"/>
    <p:restoredTop sz="94660"/>
  </p:normalViewPr>
  <p:slideViewPr>
    <p:cSldViewPr snapToGrid="0">
      <p:cViewPr>
        <p:scale>
          <a:sx n="48" d="100"/>
          <a:sy n="48" d="100"/>
        </p:scale>
        <p:origin x="67" y="8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5937F0-DB87-419C-8239-89A976B2FF4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18D7F10-1586-4D2B-A7F7-C34225F20EA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F2EE96-D103-4250-A76F-F3579E1EB9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1F16E-EEA0-4B63-972E-799D0A1C649D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E8AD2A-9A08-43AC-BAE2-5F770F1B53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FF1784-33AE-4E7A-B37F-90E6786CD5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1A3D5-DDE9-44C7-9E2F-85AA017EB1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0472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90C142-DFC9-4FF7-B143-B7DA2BBA1D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BCB218E-4E6C-4AE2-B1C9-DBA1405FFF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BD31D7-A22B-4E0A-98EB-8F44814392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1F16E-EEA0-4B63-972E-799D0A1C649D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C27D93-951B-4D6B-BF1E-EE4FF9BC29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A6BEB6-AC8A-4C11-8245-410206B155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1A3D5-DDE9-44C7-9E2F-85AA017EB1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04015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2B94357-B5AD-4588-B3F3-6018C3F5ADD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1C8F732-7B44-423E-8E14-1850FA083E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03A7F2-B2F5-409C-9760-A2CDE5B0FD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1F16E-EEA0-4B63-972E-799D0A1C649D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CDDB11-A0A9-49A0-9557-AEA7561C73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E9EC87-0A85-4D3E-825E-B563F57CBC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1A3D5-DDE9-44C7-9E2F-85AA017EB1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93497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FD6A80-22E1-4E96-AD39-3B0E78CFDC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D9B11C-A5F3-465A-A09B-0B934DF7672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22B013-E3EA-431C-B118-BEF4A42516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1F16E-EEA0-4B63-972E-799D0A1C649D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6762A7-CF2E-4B12-9611-9B44F93034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8C1660-966C-4227-B1CF-1E7DC9B5C3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1A3D5-DDE9-44C7-9E2F-85AA017EB1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44032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F60A39-6ACE-4F72-AA16-98B497C6EB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937D55-C5C2-461D-B481-CA2077740E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F94293-C6AF-43DE-A4BE-D581DADC42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1F16E-EEA0-4B63-972E-799D0A1C649D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42B616-6EAE-4D81-A18C-DEB7487EAD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2BF82B-78A3-43CF-879B-50CF00D979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1A3D5-DDE9-44C7-9E2F-85AA017EB1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7773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C9F324-5BFC-4F6F-BA77-418C53E8BC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4A912E-78DC-4248-9037-5DA30640C2B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E613F40-E9B8-4EC5-9490-ADC438E0F80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8787758-57B5-427A-BA78-D1E98BEAAE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1F16E-EEA0-4B63-972E-799D0A1C649D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D070B4C-1998-4A45-832C-CAAE890E13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5CD486E-8C74-4629-9DAB-0F0366203E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1A3D5-DDE9-44C7-9E2F-85AA017EB1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03495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AC498E-C17B-4C5E-9DF7-9A863E1981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1236E3B-2CDB-459C-9AD5-1328E99DAC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2F2CB8A-9FA8-4EBC-BA5B-2076705654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5EAF230-A8D9-4D70-A105-70A950B8F4B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066631F-AAA8-4CFC-86B9-25DCFEA1ADB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5A7DA50-50D5-4539-B8D4-E1E5C4F904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1F16E-EEA0-4B63-972E-799D0A1C649D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4E8FA0D-F4DF-4568-A26C-D2C8E9FB71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1163497-9DC5-4454-AB11-76080870B2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1A3D5-DDE9-44C7-9E2F-85AA017EB1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4792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C1CC13-00A6-47AF-B0A4-1FADB5C396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B1C7FA8-9E2C-441E-8617-9406B3E2F4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1F16E-EEA0-4B63-972E-799D0A1C649D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659E434-14C7-4C82-B305-59363921D1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91912E2-9D12-4694-823A-4A53975C4A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1A3D5-DDE9-44C7-9E2F-85AA017EB1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94618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7C987D3-59BF-4B7C-A73E-A5FFC8ED8F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1F16E-EEA0-4B63-972E-799D0A1C649D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BAA9660-094A-4755-BA11-ED2DB07976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1E3F29D-CFE1-4BA5-B853-630C4D4855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1A3D5-DDE9-44C7-9E2F-85AA017EB1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14051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D8FC9B-6BFA-416B-A313-A3FAFA9343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BE3F90-13B0-4D88-A85E-E04872AEF78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0BF4AFB-FD49-48B9-B864-D2D5239247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748C73-0DEF-4EFE-91EC-2773A5C111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1F16E-EEA0-4B63-972E-799D0A1C649D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06E37D2-B881-41E0-8D6C-EC5884DC18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B04DB0-AF25-48B9-8F21-62BCBC6F19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1A3D5-DDE9-44C7-9E2F-85AA017EB1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62848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4946F4-0811-42AD-943C-01E1B44350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DED05B9-7733-4601-A4FE-D45F7ABB9FC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971E710-3D7A-4CD4-9D03-4D505A9244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04E7FA9-11AE-46B9-9968-82500622EF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91F16E-EEA0-4B63-972E-799D0A1C649D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6E9FA4-609C-444B-965B-C37E5D541D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239CE5-B46D-4CD2-AF58-932523AB18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1A3D5-DDE9-44C7-9E2F-85AA017EB1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69905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B9733E3-C53D-4BF9-AFB0-339AC37CBB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B7A025A-0C34-4BF2-AFBE-0D5E99F1A5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730ED7-47D1-4B76-9FC0-ACDB23ED2AA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91F16E-EEA0-4B63-972E-799D0A1C649D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F27811-3363-41D3-B479-AA312D8F06D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E0817D-A0B2-404A-B2FB-220021F0B58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51A3D5-DDE9-44C7-9E2F-85AA017EB1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40678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64AFAB-9DE9-474F-BEC3-056821762552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upplementary Material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A7D8B98-BA69-4824-8F47-282B05911B41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10020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853E0BA-2394-4BE6-B938-89D0377366E3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75942" y="0"/>
            <a:ext cx="5608955" cy="7029450"/>
          </a:xfrm>
          <a:prstGeom prst="rect">
            <a:avLst/>
          </a:prstGeom>
          <a:noFill/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90A98EF-2033-46E3-87DA-4F5EB179C9FD}"/>
              </a:ext>
            </a:extLst>
          </p:cNvPr>
          <p:cNvSpPr txBox="1"/>
          <p:nvPr/>
        </p:nvSpPr>
        <p:spPr>
          <a:xfrm>
            <a:off x="0" y="152218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 Table 1</a:t>
            </a:r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1931E82-7BB4-4DB4-8F98-914666A27FCA}"/>
              </a:ext>
            </a:extLst>
          </p:cNvPr>
          <p:cNvSpPr txBox="1"/>
          <p:nvPr/>
        </p:nvSpPr>
        <p:spPr>
          <a:xfrm>
            <a:off x="545432" y="2106870"/>
            <a:ext cx="3400926" cy="33372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Table 1: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atistically significant</a:t>
            </a:r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mparison using a one-way ANOVA and Tukey’s multiple comparison test between all groups for age, WBC, Hb, RBC, and PLT. 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007592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F2A643ED-BD97-4847-A5DC-D859A7F2304C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9755" y="587442"/>
            <a:ext cx="7409163" cy="5683115"/>
          </a:xfrm>
          <a:prstGeom prst="rect">
            <a:avLst/>
          </a:prstGeom>
          <a:noFill/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6FF2934-FB19-47E5-A6E7-C091AD797B69}"/>
              </a:ext>
            </a:extLst>
          </p:cNvPr>
          <p:cNvSpPr txBox="1"/>
          <p:nvPr/>
        </p:nvSpPr>
        <p:spPr>
          <a:xfrm>
            <a:off x="128337" y="152218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 Table 2</a:t>
            </a:r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EBF83CA-B1C6-4145-8F0A-15F27BC894EB}"/>
              </a:ext>
            </a:extLst>
          </p:cNvPr>
          <p:cNvSpPr txBox="1"/>
          <p:nvPr/>
        </p:nvSpPr>
        <p:spPr>
          <a:xfrm>
            <a:off x="200526" y="6138511"/>
            <a:ext cx="11790947" cy="5672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Table 2: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ne-way ANOVA and Tukey’s multiple comparison test between all genotypes for each cytokine. 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32917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1E7314C-89B0-4A12-8B5B-A0AEDA632B00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96339" y="133362"/>
            <a:ext cx="8143324" cy="5595938"/>
          </a:xfrm>
          <a:prstGeom prst="rect">
            <a:avLst/>
          </a:prstGeom>
          <a:noFill/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8D97CB7-AEC3-4C61-87B4-38673A9F989E}"/>
              </a:ext>
            </a:extLst>
          </p:cNvPr>
          <p:cNvSpPr txBox="1"/>
          <p:nvPr/>
        </p:nvSpPr>
        <p:spPr>
          <a:xfrm>
            <a:off x="0" y="133362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 Table 3</a:t>
            </a:r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F41F568-3D65-4B54-B453-4E4082DAA34F}"/>
              </a:ext>
            </a:extLst>
          </p:cNvPr>
          <p:cNvSpPr txBox="1"/>
          <p:nvPr/>
        </p:nvSpPr>
        <p:spPr>
          <a:xfrm>
            <a:off x="0" y="5603369"/>
            <a:ext cx="11919284" cy="11212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Table 3: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atistically significant</a:t>
            </a:r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mparison using two-tailed t-test or Mann Whitney test between all genotypes for each cytokine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11536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4E8016E-C855-4E70-96A1-15D79C84F078}"/>
              </a:ext>
            </a:extLst>
          </p:cNvPr>
          <p:cNvSpPr txBox="1"/>
          <p:nvPr/>
        </p:nvSpPr>
        <p:spPr>
          <a:xfrm>
            <a:off x="124210" y="136176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 Table 4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: </a:t>
            </a:r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92B4C9B-BDF9-4778-879A-AA9B8BADF38F}"/>
              </a:ext>
            </a:extLst>
          </p:cNvPr>
          <p:cNvSpPr txBox="1"/>
          <p:nvPr/>
        </p:nvSpPr>
        <p:spPr>
          <a:xfrm>
            <a:off x="236505" y="6075493"/>
            <a:ext cx="1115339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 Table 4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: Pearson correlations between cytokine and Hb genotype for WBC counts evaluated using R</a:t>
            </a:r>
            <a:r>
              <a:rPr lang="en-US" sz="18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2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and P-values.</a:t>
            </a:r>
            <a:endParaRPr lang="en-US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BB316266-700B-45F6-94BC-677F7A7277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15367" y="505508"/>
            <a:ext cx="10274528" cy="53140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3913447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474AF7B-325A-4F50-909E-6B235673BBDA}"/>
              </a:ext>
            </a:extLst>
          </p:cNvPr>
          <p:cNvSpPr txBox="1"/>
          <p:nvPr/>
        </p:nvSpPr>
        <p:spPr>
          <a:xfrm>
            <a:off x="208547" y="136176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 Table 5</a:t>
            </a:r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076F751-6DE5-4843-AAB0-3CB82C0704F4}"/>
              </a:ext>
            </a:extLst>
          </p:cNvPr>
          <p:cNvSpPr txBox="1"/>
          <p:nvPr/>
        </p:nvSpPr>
        <p:spPr>
          <a:xfrm>
            <a:off x="368968" y="5662863"/>
            <a:ext cx="10940716" cy="11212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Table 5: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earson correlations between cytokine and Hb genotype for Hb levels evaluated using R</a:t>
            </a:r>
            <a:r>
              <a:rPr lang="en-US" sz="18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P-values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95203338-84F7-404B-9546-ECE07FF07B6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2000" y="651565"/>
            <a:ext cx="9528000" cy="49327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616742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CE8604A-1CCE-48F2-9542-CC60E42FD591}"/>
              </a:ext>
            </a:extLst>
          </p:cNvPr>
          <p:cNvSpPr txBox="1"/>
          <p:nvPr/>
        </p:nvSpPr>
        <p:spPr>
          <a:xfrm>
            <a:off x="148272" y="192141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 Table 6</a:t>
            </a:r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CDF6980-BAE0-45A2-B867-47295F58FF45}"/>
              </a:ext>
            </a:extLst>
          </p:cNvPr>
          <p:cNvSpPr txBox="1"/>
          <p:nvPr/>
        </p:nvSpPr>
        <p:spPr>
          <a:xfrm>
            <a:off x="148272" y="5544590"/>
            <a:ext cx="11341768" cy="11212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Table 6: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earson correlations between cytokine and Hb genotype for RBC counts evaluated using R</a:t>
            </a:r>
            <a:r>
              <a:rPr lang="en-US" sz="18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P-values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AEB96A6-EAB8-42CE-A171-EA9860F0027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49556" y="561473"/>
            <a:ext cx="9889517" cy="52750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5862701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4399DA7-F31B-48CD-9F8A-7BA5C2DD15C3}"/>
              </a:ext>
            </a:extLst>
          </p:cNvPr>
          <p:cNvSpPr txBox="1"/>
          <p:nvPr/>
        </p:nvSpPr>
        <p:spPr>
          <a:xfrm>
            <a:off x="148272" y="192141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 Figure 1</a:t>
            </a:r>
            <a:endParaRPr lang="en-US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025E644-A71C-4A4E-9C3A-0E0175B600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26951" y="108155"/>
            <a:ext cx="4538158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8C2E3E7-98D6-4091-A2E9-6AD2B77236AE}"/>
              </a:ext>
            </a:extLst>
          </p:cNvPr>
          <p:cNvSpPr txBox="1"/>
          <p:nvPr/>
        </p:nvSpPr>
        <p:spPr>
          <a:xfrm>
            <a:off x="462115" y="1368102"/>
            <a:ext cx="3883742" cy="38373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Figure 1: Comparisons cytokines for genotypes with and without malaria using t-tests.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aphs are box and whisker plots showing minimum and maximum.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, Unpaired two-tailed t-test for CXCL10 was used to compare HbAA- vs HbSS- (P=0.04) and HbAA- vs HbSC- (P=0.02). B, Unpaired two-tailed t-test for CXCL10 was run in HbAA- vs HbAA+ (P=0.01), HbAA- vs HbSS+ (P=0.0001), and HbAC- vs HbAC+ (P=0.03). C, A two-tailed Mann-Whitney test was used to compare CCL2 in HbAA- vs HbSS+ (P=0.04). D, A two-tailed Mann-Whitney test was used to compare TNF-α in HbAA- vs HbSS- (P=0.03). E, An unpaired two-tailed t-test was used to compare CCL3 in HbAC- vs HbAC+ (P=0.03) and a Mann-Whitney test used to compare HbAS+ vs HbAS+ (P=0.008). F, An unpaired two-tailed t-test was used to compare IL-8 in HbAC- vs HbAC+ (P=0.01) as well as HbAA+ vs HbSS+ (P=0.007). G, An unpaired two-tailed t-test was used to compare IL-6 in HbAA- vs HbAA+ (P=0.01) as well as HbAC- vs HbAC+ (P=0.03)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732338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942</TotalTime>
  <Words>392</Words>
  <Application>Microsoft Office PowerPoint</Application>
  <PresentationFormat>Widescreen</PresentationFormat>
  <Paragraphs>15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Office Theme</vt:lpstr>
      <vt:lpstr>Supplementary Material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Material</dc:title>
  <dc:creator>Harp, Keri</dc:creator>
  <cp:lastModifiedBy>Harp, Keri</cp:lastModifiedBy>
  <cp:revision>7</cp:revision>
  <dcterms:created xsi:type="dcterms:W3CDTF">2020-08-07T16:20:13Z</dcterms:created>
  <dcterms:modified xsi:type="dcterms:W3CDTF">2020-12-16T20:31:18Z</dcterms:modified>
</cp:coreProperties>
</file>